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6256000" cy="12192000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67" d="100"/>
          <a:sy n="67" d="100"/>
        </p:scale>
        <p:origin x="131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4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2E34-8C41-49CE-8285-CE69B51F9428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0E6FE-3BE9-4086-9E2B-C10F2C11F9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2323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2E34-8C41-49CE-8285-CE69B51F9428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0E6FE-3BE9-4086-9E2B-C10F2C11F9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9552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2" y="649111"/>
            <a:ext cx="3505199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1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2E34-8C41-49CE-8285-CE69B51F9428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0E6FE-3BE9-4086-9E2B-C10F2C11F9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5560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2E34-8C41-49CE-8285-CE69B51F9428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0E6FE-3BE9-4086-9E2B-C10F2C11F9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1584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5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5" y="8159049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2E34-8C41-49CE-8285-CE69B51F9428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0E6FE-3BE9-4086-9E2B-C10F2C11F9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8041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1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1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2E34-8C41-49CE-8285-CE69B51F9428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0E6FE-3BE9-4086-9E2B-C10F2C11F9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5897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9" y="649114"/>
            <a:ext cx="14020800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8"/>
            <a:ext cx="6877049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2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2" y="4453468"/>
            <a:ext cx="6910917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2E34-8C41-49CE-8285-CE69B51F9428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0E6FE-3BE9-4086-9E2B-C10F2C11F9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90603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2E34-8C41-49CE-8285-CE69B51F9428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0E6FE-3BE9-4086-9E2B-C10F2C11F9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1441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2E34-8C41-49CE-8285-CE69B51F9428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0E6FE-3BE9-4086-9E2B-C10F2C11F9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0321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8" y="812800"/>
            <a:ext cx="5242984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8" y="1755425"/>
            <a:ext cx="8229601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8" y="3657600"/>
            <a:ext cx="5242984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2E34-8C41-49CE-8285-CE69B51F9428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0E6FE-3BE9-4086-9E2B-C10F2C11F9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9737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8" y="812800"/>
            <a:ext cx="5242984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8" y="1755425"/>
            <a:ext cx="8229601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8" y="3657600"/>
            <a:ext cx="5242984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82E34-8C41-49CE-8285-CE69B51F9428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0E6FE-3BE9-4086-9E2B-C10F2C11F9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6081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2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2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1" y="11300182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F82E34-8C41-49CE-8285-CE69B51F9428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2" y="11300182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1" y="11300182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0E6FE-3BE9-4086-9E2B-C10F2C11F9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4299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D2F33306-F264-450B-B0F7-10E7DB4F8930}"/>
              </a:ext>
            </a:extLst>
          </p:cNvPr>
          <p:cNvSpPr txBox="1"/>
          <p:nvPr/>
        </p:nvSpPr>
        <p:spPr>
          <a:xfrm>
            <a:off x="475678" y="899878"/>
            <a:ext cx="1472456" cy="492443"/>
          </a:xfrm>
          <a:prstGeom prst="rect">
            <a:avLst/>
          </a:prstGeom>
          <a:noFill/>
          <a:ln w="28575">
            <a:solidFill>
              <a:schemeClr val="accent6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GB" sz="3200" dirty="0">
                <a:latin typeface="Arial" panose="020B0604020202020204" pitchFamily="34" charset="0"/>
                <a:cs typeface="Arial" panose="020B0604020202020204" pitchFamily="34" charset="0"/>
              </a:rPr>
              <a:t>MG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F47169F8-F5B4-48DD-A56A-991403B14640}"/>
              </a:ext>
            </a:extLst>
          </p:cNvPr>
          <p:cNvSpPr txBox="1"/>
          <p:nvPr/>
        </p:nvSpPr>
        <p:spPr>
          <a:xfrm rot="16200000">
            <a:off x="278931" y="2993798"/>
            <a:ext cx="1330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-</a:t>
            </a:r>
            <a:r>
              <a:rPr lang="en-GB" sz="2400" dirty="0"/>
              <a:t>log</a:t>
            </a:r>
            <a:r>
              <a:rPr lang="en-GB" sz="2400" baseline="-25000" dirty="0"/>
              <a:t>10</a:t>
            </a:r>
            <a:r>
              <a:rPr lang="en-GB" sz="1200" dirty="0"/>
              <a:t>(</a:t>
            </a:r>
            <a:r>
              <a:rPr lang="en-GB" sz="1200" dirty="0" err="1"/>
              <a:t>P</a:t>
            </a:r>
            <a:r>
              <a:rPr lang="en-GB" sz="1200" baseline="-25000" dirty="0" err="1"/>
              <a:t>adj</a:t>
            </a:r>
            <a:r>
              <a:rPr lang="en-GB" sz="1200" dirty="0"/>
              <a:t>)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728408E3-9097-4F9F-B17C-FA9F8A57A189}"/>
              </a:ext>
            </a:extLst>
          </p:cNvPr>
          <p:cNvSpPr txBox="1"/>
          <p:nvPr/>
        </p:nvSpPr>
        <p:spPr>
          <a:xfrm rot="16200000">
            <a:off x="-720540" y="3055637"/>
            <a:ext cx="2213704" cy="400110"/>
          </a:xfrm>
          <a:prstGeom prst="rect">
            <a:avLst/>
          </a:prstGeom>
          <a:solidFill>
            <a:srgbClr val="CC33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latin typeface="Arial" panose="020B0604020202020204" pitchFamily="34" charset="0"/>
                <a:cs typeface="Arial" panose="020B0604020202020204" pitchFamily="34" charset="0"/>
              </a:rPr>
              <a:t>Up-regulated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77B342AD-F823-4553-8958-00DD807FA137}"/>
              </a:ext>
            </a:extLst>
          </p:cNvPr>
          <p:cNvSpPr txBox="1"/>
          <p:nvPr/>
        </p:nvSpPr>
        <p:spPr>
          <a:xfrm rot="16200000">
            <a:off x="-720540" y="6139321"/>
            <a:ext cx="2213703" cy="400110"/>
          </a:xfrm>
          <a:prstGeom prst="rect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latin typeface="Arial" panose="020B0604020202020204" pitchFamily="34" charset="0"/>
                <a:cs typeface="Arial" panose="020B0604020202020204" pitchFamily="34" charset="0"/>
              </a:rPr>
              <a:t>Down-regulated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8D652829-FBBA-4C29-A3A9-308383074350}"/>
              </a:ext>
            </a:extLst>
          </p:cNvPr>
          <p:cNvSpPr txBox="1"/>
          <p:nvPr/>
        </p:nvSpPr>
        <p:spPr>
          <a:xfrm rot="16200000">
            <a:off x="251957" y="6295076"/>
            <a:ext cx="14401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-</a:t>
            </a:r>
            <a:r>
              <a:rPr lang="en-GB" sz="2400" dirty="0"/>
              <a:t>log</a:t>
            </a:r>
            <a:r>
              <a:rPr lang="en-GB" sz="2400" baseline="-25000" dirty="0"/>
              <a:t>10</a:t>
            </a:r>
            <a:r>
              <a:rPr lang="en-GB" sz="1200" dirty="0"/>
              <a:t>(</a:t>
            </a:r>
            <a:r>
              <a:rPr lang="en-GB" sz="1200" dirty="0" err="1"/>
              <a:t>P</a:t>
            </a:r>
            <a:r>
              <a:rPr lang="en-GB" sz="1200" baseline="-25000" dirty="0" err="1"/>
              <a:t>adj</a:t>
            </a:r>
            <a:r>
              <a:rPr lang="en-GB" sz="1200" dirty="0"/>
              <a:t>)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F3848C35-15D0-4C4A-A6D8-2DFFAEA419EA}"/>
              </a:ext>
            </a:extLst>
          </p:cNvPr>
          <p:cNvSpPr txBox="1"/>
          <p:nvPr/>
        </p:nvSpPr>
        <p:spPr>
          <a:xfrm>
            <a:off x="6572250" y="428625"/>
            <a:ext cx="399288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b="1" u="sng" dirty="0"/>
              <a:t>GO enrichment analysi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="" xmlns:a16="http://schemas.microsoft.com/office/drawing/2014/main" id="{4CBD4243-280D-4631-9777-7E327EE97E4D}"/>
              </a:ext>
            </a:extLst>
          </p:cNvPr>
          <p:cNvSpPr txBox="1"/>
          <p:nvPr/>
        </p:nvSpPr>
        <p:spPr>
          <a:xfrm>
            <a:off x="3263265" y="1535175"/>
            <a:ext cx="3346260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eto </a:t>
            </a:r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ne </a:t>
            </a:r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vs control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FBDC1987-01B4-4931-B2A4-562CB19ABD3C}"/>
              </a:ext>
            </a:extLst>
          </p:cNvPr>
          <p:cNvSpPr txBox="1"/>
          <p:nvPr/>
        </p:nvSpPr>
        <p:spPr>
          <a:xfrm>
            <a:off x="10802072" y="1560917"/>
            <a:ext cx="343664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l-G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2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ro</a:t>
            </a:r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ne </a:t>
            </a:r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vs control</a:t>
            </a:r>
          </a:p>
        </p:txBody>
      </p:sp>
      <p:pic>
        <p:nvPicPr>
          <p:cNvPr id="55" name="Picture 5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1724" y="2163864"/>
            <a:ext cx="15186452" cy="59441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430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</TotalTime>
  <Words>21</Words>
  <Application>Microsoft Office PowerPoint</Application>
  <PresentationFormat>Custom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gueira, Marilise</dc:creator>
  <cp:lastModifiedBy>marilise nogueira</cp:lastModifiedBy>
  <cp:revision>8</cp:revision>
  <cp:lastPrinted>2021-11-30T16:04:53Z</cp:lastPrinted>
  <dcterms:created xsi:type="dcterms:W3CDTF">2021-11-30T15:35:29Z</dcterms:created>
  <dcterms:modified xsi:type="dcterms:W3CDTF">2022-10-19T08:48:58Z</dcterms:modified>
</cp:coreProperties>
</file>